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60" d="100"/>
          <a:sy n="160" d="100"/>
        </p:scale>
        <p:origin x="-972" y="48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17627B-5181-4702-B2D0-A16014204A02}" type="datetimeFigureOut">
              <a:rPr kumimoji="1" lang="ja-JP" altLang="en-US" smtClean="0"/>
              <a:t>2013/1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A084C-0CC8-4317-BB21-9A0E090F6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91497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17627B-5181-4702-B2D0-A16014204A02}" type="datetimeFigureOut">
              <a:rPr kumimoji="1" lang="ja-JP" altLang="en-US" smtClean="0"/>
              <a:t>2013/1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A084C-0CC8-4317-BB21-9A0E090F6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94676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17627B-5181-4702-B2D0-A16014204A02}" type="datetimeFigureOut">
              <a:rPr kumimoji="1" lang="ja-JP" altLang="en-US" smtClean="0"/>
              <a:t>2013/1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A084C-0CC8-4317-BB21-9A0E090F6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60747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17627B-5181-4702-B2D0-A16014204A02}" type="datetimeFigureOut">
              <a:rPr kumimoji="1" lang="ja-JP" altLang="en-US" smtClean="0"/>
              <a:t>2013/1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A084C-0CC8-4317-BB21-9A0E090F6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44237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17627B-5181-4702-B2D0-A16014204A02}" type="datetimeFigureOut">
              <a:rPr kumimoji="1" lang="ja-JP" altLang="en-US" smtClean="0"/>
              <a:t>2013/1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A084C-0CC8-4317-BB21-9A0E090F6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56718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17627B-5181-4702-B2D0-A16014204A02}" type="datetimeFigureOut">
              <a:rPr kumimoji="1" lang="ja-JP" altLang="en-US" smtClean="0"/>
              <a:t>2013/1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A084C-0CC8-4317-BB21-9A0E090F6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5073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17627B-5181-4702-B2D0-A16014204A02}" type="datetimeFigureOut">
              <a:rPr kumimoji="1" lang="ja-JP" altLang="en-US" smtClean="0"/>
              <a:t>2013/1/23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A084C-0CC8-4317-BB21-9A0E090F6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04067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17627B-5181-4702-B2D0-A16014204A02}" type="datetimeFigureOut">
              <a:rPr kumimoji="1" lang="ja-JP" altLang="en-US" smtClean="0"/>
              <a:t>2013/1/2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A084C-0CC8-4317-BB21-9A0E090F6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20762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17627B-5181-4702-B2D0-A16014204A02}" type="datetimeFigureOut">
              <a:rPr kumimoji="1" lang="ja-JP" altLang="en-US" smtClean="0"/>
              <a:t>2013/1/23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A084C-0CC8-4317-BB21-9A0E090F6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15275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17627B-5181-4702-B2D0-A16014204A02}" type="datetimeFigureOut">
              <a:rPr kumimoji="1" lang="ja-JP" altLang="en-US" smtClean="0"/>
              <a:t>2013/1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A084C-0CC8-4317-BB21-9A0E090F6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01922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17627B-5181-4702-B2D0-A16014204A02}" type="datetimeFigureOut">
              <a:rPr kumimoji="1" lang="ja-JP" altLang="en-US" smtClean="0"/>
              <a:t>2013/1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A084C-0CC8-4317-BB21-9A0E090F6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58258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17627B-5181-4702-B2D0-A16014204A02}" type="datetimeFigureOut">
              <a:rPr kumimoji="1" lang="ja-JP" altLang="en-US" smtClean="0"/>
              <a:t>2013/1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CA084C-0CC8-4317-BB21-9A0E090F6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30191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10" Type="http://schemas.openxmlformats.org/officeDocument/2006/relationships/image" Target="../media/image8.jpeg"/><Relationship Id="rId4" Type="http://schemas.openxmlformats.org/officeDocument/2006/relationships/image" Target="../media/image3.jpeg"/><Relationship Id="rId9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/>
          <p:cNvGrpSpPr/>
          <p:nvPr/>
        </p:nvGrpSpPr>
        <p:grpSpPr>
          <a:xfrm>
            <a:off x="1426935" y="687023"/>
            <a:ext cx="4772031" cy="1742401"/>
            <a:chOff x="1426935" y="687023"/>
            <a:chExt cx="4772031" cy="1742401"/>
          </a:xfrm>
        </p:grpSpPr>
        <p:grpSp>
          <p:nvGrpSpPr>
            <p:cNvPr id="65" name="グループ化 64"/>
            <p:cNvGrpSpPr>
              <a:grpSpLocks noChangeAspect="1"/>
            </p:cNvGrpSpPr>
            <p:nvPr/>
          </p:nvGrpSpPr>
          <p:grpSpPr>
            <a:xfrm>
              <a:off x="3875765" y="687024"/>
              <a:ext cx="2323201" cy="1742400"/>
              <a:chOff x="5364088" y="4139203"/>
              <a:chExt cx="3312368" cy="2484275"/>
            </a:xfrm>
          </p:grpSpPr>
          <p:pic>
            <p:nvPicPr>
              <p:cNvPr id="66" name="Picture 8" descr="J:\FUJIKAWA\NIFTS\研究\グリーニング\FISH\Fujikawa20110714\FISH1\Hea0707p5\Heal-FISH-DAPI-2.jpg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 rot="5400000">
                <a:off x="5778134" y="3725157"/>
                <a:ext cx="2484275" cy="3312368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67" name="直線コネクタ 66"/>
              <p:cNvCxnSpPr/>
              <p:nvPr/>
            </p:nvCxnSpPr>
            <p:spPr>
              <a:xfrm>
                <a:off x="8172400" y="6394968"/>
                <a:ext cx="346991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8" name="グループ化 67"/>
            <p:cNvGrpSpPr>
              <a:grpSpLocks noChangeAspect="1"/>
            </p:cNvGrpSpPr>
            <p:nvPr/>
          </p:nvGrpSpPr>
          <p:grpSpPr>
            <a:xfrm>
              <a:off x="1426935" y="687023"/>
              <a:ext cx="2323201" cy="1742400"/>
              <a:chOff x="1614874" y="4127593"/>
              <a:chExt cx="3317165" cy="2487873"/>
            </a:xfrm>
          </p:grpSpPr>
          <p:pic>
            <p:nvPicPr>
              <p:cNvPr id="69" name="Picture 9" descr="J:\FUJIKAWA\NIFTS\研究\グリーニング\FISH\Fujikawa20110714\FISH1\Hea0707p5\Heal-FISH-FISH-2.jpg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 rot="5400000">
                <a:off x="2029520" y="3712947"/>
                <a:ext cx="2487873" cy="3317165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70" name="直線コネクタ 69"/>
              <p:cNvCxnSpPr/>
              <p:nvPr/>
            </p:nvCxnSpPr>
            <p:spPr>
              <a:xfrm>
                <a:off x="4427984" y="6394968"/>
                <a:ext cx="346991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47" name="テキスト ボックス 46"/>
          <p:cNvSpPr txBox="1"/>
          <p:nvPr/>
        </p:nvSpPr>
        <p:spPr>
          <a:xfrm>
            <a:off x="2797307" y="35496"/>
            <a:ext cx="12490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Figure S3.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46608" y="8244408"/>
            <a:ext cx="6741368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Figure S3.</a:t>
            </a:r>
            <a:r>
              <a:rPr kumimoji="1"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</a:t>
            </a:r>
            <a:r>
              <a:rPr kumimoji="1"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FISH assay with various probes. The </a:t>
            </a:r>
            <a:r>
              <a:rPr kumimoji="1" lang="en-US" altLang="ja-JP" sz="1100" i="1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Biomasher</a:t>
            </a:r>
            <a:r>
              <a:rPr kumimoji="1" lang="en-US" altLang="ja-JP" sz="1100" i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-pellet </a:t>
            </a:r>
            <a:r>
              <a:rPr kumimoji="1"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from healthy leaves were filtered </a:t>
            </a:r>
            <a:r>
              <a:rPr lang="en-US" altLang="ja-JP" sz="1100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with 5 µm </a:t>
            </a:r>
            <a:r>
              <a:rPr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and used </a:t>
            </a:r>
            <a:r>
              <a:rPr kumimoji="1"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for FISH assay. Left panels, FISH with respective probes; right panels, DAPI staining. Scale bars </a:t>
            </a:r>
            <a:r>
              <a:rPr lang="en-US" altLang="ja-JP" sz="1100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indicate 10 </a:t>
            </a:r>
            <a:r>
              <a:rPr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µm. A, LSS (Las-specific) probe; B,  ALF968 (</a:t>
            </a:r>
            <a:r>
              <a:rPr lang="el-GR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α</a:t>
            </a:r>
            <a:r>
              <a:rPr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-proteobacteria-specific) probe; C, EUB338 (eubacteria-specific) probe; D, NON (invalid) probe. </a:t>
            </a:r>
            <a:endParaRPr kumimoji="1" lang="ja-JP" altLang="en-US" sz="11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1002214" y="68356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A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58" name="テキスト ボックス 57"/>
          <p:cNvSpPr txBox="1"/>
          <p:nvPr/>
        </p:nvSpPr>
        <p:spPr>
          <a:xfrm>
            <a:off x="1000184" y="2546532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B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59" name="テキスト ボックス 58"/>
          <p:cNvSpPr txBox="1"/>
          <p:nvPr/>
        </p:nvSpPr>
        <p:spPr>
          <a:xfrm>
            <a:off x="1009912" y="444224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C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0" name="テキスト ボックス 59"/>
          <p:cNvSpPr txBox="1"/>
          <p:nvPr/>
        </p:nvSpPr>
        <p:spPr>
          <a:xfrm>
            <a:off x="1021670" y="631444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D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grpSp>
        <p:nvGrpSpPr>
          <p:cNvPr id="12" name="グループ化 11"/>
          <p:cNvGrpSpPr/>
          <p:nvPr/>
        </p:nvGrpSpPr>
        <p:grpSpPr>
          <a:xfrm>
            <a:off x="3874113" y="2555776"/>
            <a:ext cx="2325143" cy="1742400"/>
            <a:chOff x="3874113" y="2555776"/>
            <a:chExt cx="2325143" cy="1742400"/>
          </a:xfrm>
        </p:grpSpPr>
        <p:pic>
          <p:nvPicPr>
            <p:cNvPr id="57" name="Picture 4" descr="J:\FUJIKAWA\NIFTS\研究\グリーニング\FISH\Fujikawa20110714\ALF\Hea0707p5\Heal-ALF-DAPI.jpg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74113" y="2555776"/>
              <a:ext cx="2325143" cy="17424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72" name="直線コネクタ 71"/>
            <p:cNvCxnSpPr/>
            <p:nvPr/>
          </p:nvCxnSpPr>
          <p:spPr>
            <a:xfrm>
              <a:off x="5877318" y="4134110"/>
              <a:ext cx="24337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" name="グループ化 2"/>
          <p:cNvGrpSpPr/>
          <p:nvPr/>
        </p:nvGrpSpPr>
        <p:grpSpPr>
          <a:xfrm>
            <a:off x="1412776" y="2558666"/>
            <a:ext cx="2325143" cy="1742400"/>
            <a:chOff x="1412776" y="2558666"/>
            <a:chExt cx="2325143" cy="1742400"/>
          </a:xfrm>
        </p:grpSpPr>
        <p:pic>
          <p:nvPicPr>
            <p:cNvPr id="61" name="Picture 5" descr="J:\FUJIKAWA\NIFTS\研究\グリーニング\FISH\Fujikawa20110714\ALF\Hea0707p5\Heal-ALF-ALF.jpg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12776" y="2558666"/>
              <a:ext cx="2325143" cy="17424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73" name="直線コネクタ 72"/>
            <p:cNvCxnSpPr/>
            <p:nvPr/>
          </p:nvCxnSpPr>
          <p:spPr>
            <a:xfrm>
              <a:off x="3429000" y="4139952"/>
              <a:ext cx="243018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4" name="グループ化 23"/>
          <p:cNvGrpSpPr/>
          <p:nvPr/>
        </p:nvGrpSpPr>
        <p:grpSpPr>
          <a:xfrm>
            <a:off x="3877256" y="4438839"/>
            <a:ext cx="2322000" cy="1742400"/>
            <a:chOff x="3877256" y="4438839"/>
            <a:chExt cx="2322000" cy="1742400"/>
          </a:xfrm>
        </p:grpSpPr>
        <p:pic>
          <p:nvPicPr>
            <p:cNvPr id="62" name="Picture 5" descr="J:\FUJIKAWA\NIFTS\研究\グリーニング\FISH\Fujikawa20110714\EUB\Hea0707p5\Heal-EUB-DAPI.jpg"/>
            <p:cNvPicPr>
              <a:picLocks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5400000">
              <a:off x="4167056" y="4149039"/>
              <a:ext cx="1742400" cy="232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74" name="直線コネクタ 73"/>
            <p:cNvCxnSpPr/>
            <p:nvPr/>
          </p:nvCxnSpPr>
          <p:spPr>
            <a:xfrm>
              <a:off x="5877318" y="6006318"/>
              <a:ext cx="24337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1" name="グループ化 20"/>
          <p:cNvGrpSpPr/>
          <p:nvPr/>
        </p:nvGrpSpPr>
        <p:grpSpPr>
          <a:xfrm>
            <a:off x="1428488" y="4443213"/>
            <a:ext cx="2322000" cy="1742400"/>
            <a:chOff x="1428488" y="4443213"/>
            <a:chExt cx="2322000" cy="1742400"/>
          </a:xfrm>
        </p:grpSpPr>
        <p:pic>
          <p:nvPicPr>
            <p:cNvPr id="63" name="Picture 4" descr="J:\FUJIKAWA\NIFTS\研究\グリーニング\FISH\Fujikawa20110714\EUB\Hea0707p5\Heal-EUB-EUB.jpg"/>
            <p:cNvPicPr>
              <a:picLocks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5400000">
              <a:off x="1718288" y="4153413"/>
              <a:ext cx="1742400" cy="232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75" name="直線コネクタ 74"/>
            <p:cNvCxnSpPr/>
            <p:nvPr/>
          </p:nvCxnSpPr>
          <p:spPr>
            <a:xfrm>
              <a:off x="3429000" y="6012160"/>
              <a:ext cx="243018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6" name="グループ化 25"/>
          <p:cNvGrpSpPr/>
          <p:nvPr/>
        </p:nvGrpSpPr>
        <p:grpSpPr>
          <a:xfrm>
            <a:off x="3877256" y="6314448"/>
            <a:ext cx="2325143" cy="1742400"/>
            <a:chOff x="3877256" y="6314448"/>
            <a:chExt cx="2325143" cy="1742400"/>
          </a:xfrm>
        </p:grpSpPr>
        <p:pic>
          <p:nvPicPr>
            <p:cNvPr id="64" name="Picture 5" descr="J:\FUJIKAWA\NIFTS\研究\グリーニング\FISH\Fujikawa20110714\NON\Hea0707p5\Heal-NON-DAPI.jpg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49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77256" y="6314448"/>
              <a:ext cx="2325143" cy="17424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76" name="直線コネクタ 75"/>
            <p:cNvCxnSpPr/>
            <p:nvPr/>
          </p:nvCxnSpPr>
          <p:spPr>
            <a:xfrm>
              <a:off x="5877318" y="7878526"/>
              <a:ext cx="24337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5" name="グループ化 24"/>
          <p:cNvGrpSpPr/>
          <p:nvPr/>
        </p:nvGrpSpPr>
        <p:grpSpPr>
          <a:xfrm>
            <a:off x="1424065" y="6318392"/>
            <a:ext cx="2325143" cy="1742400"/>
            <a:chOff x="1424065" y="6318392"/>
            <a:chExt cx="2325143" cy="1742400"/>
          </a:xfrm>
        </p:grpSpPr>
        <p:pic>
          <p:nvPicPr>
            <p:cNvPr id="71" name="Picture 2" descr="J:\FUJIKAWA\NIFTS\研究\グリーニング\FISH\Fujikawa20110714\NON\Ishi0707p5\Ishi1-NON-NON.jpg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24065" y="6318392"/>
              <a:ext cx="2325143" cy="17424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77" name="直線コネクタ 76"/>
            <p:cNvCxnSpPr/>
            <p:nvPr/>
          </p:nvCxnSpPr>
          <p:spPr>
            <a:xfrm>
              <a:off x="3429000" y="7884368"/>
              <a:ext cx="243018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3560788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1</TotalTime>
  <Words>85</Words>
  <Application>Microsoft Office PowerPoint</Application>
  <PresentationFormat>画面に合わせる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Fujikawa</dc:creator>
  <cp:lastModifiedBy>Fujikawa</cp:lastModifiedBy>
  <cp:revision>6</cp:revision>
  <dcterms:created xsi:type="dcterms:W3CDTF">2012-08-17T00:11:42Z</dcterms:created>
  <dcterms:modified xsi:type="dcterms:W3CDTF">2013-01-23T00:40:51Z</dcterms:modified>
</cp:coreProperties>
</file>